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B99025-BA63-4DB6-9932-BB783C0833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2E0BC5-6942-4C8E-9DFF-2B6D0F91CE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B29CB-510C-4702-A11A-D0AA5BFAD7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1C5410-43A1-4D19-915B-E59AF00F5F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2FBAC-2A78-47AA-B59A-42AE524FFD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B12644-894E-40CF-981A-4F8DFCF298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9118D6-2588-4A69-940B-C960D3A04B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82230-DB8C-456D-963D-8F8EE61B10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69116E-B56A-478D-A2B4-BE1F15EFFE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D7A24-8F0A-406C-9309-9D4FAD93FA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3757B6-2E3E-4377-831A-C3399BADA1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B04B9-F852-4BF4-9179-D7C66B8E42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4B8AAD-18B8-4D07-AC83-18DAAE7C2F5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072400" y="6652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595880" y="6652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1287720" y="1554840"/>
            <a:ext cx="3609000" cy="1893240"/>
            <a:chOff x="1287720" y="1554840"/>
            <a:chExt cx="3609000" cy="1893240"/>
          </a:xfrm>
        </p:grpSpPr>
        <p:pic>
          <p:nvPicPr>
            <p:cNvPr id="44" name="" descr=""/>
            <p:cNvPicPr/>
            <p:nvPr/>
          </p:nvPicPr>
          <p:blipFill>
            <a:blip r:embed="rId1"/>
            <a:srcRect l="35757" t="0" r="15322" b="38817"/>
            <a:stretch/>
          </p:blipFill>
          <p:spPr>
            <a:xfrm>
              <a:off x="3317760" y="2208240"/>
              <a:ext cx="1002960" cy="555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2"/>
            <a:srcRect l="33482" t="42488" r="25595" b="40532"/>
            <a:stretch/>
          </p:blipFill>
          <p:spPr>
            <a:xfrm>
              <a:off x="2241360" y="2214720"/>
              <a:ext cx="791640" cy="33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3"/>
            <a:srcRect l="48878" t="0" r="2283" b="0"/>
            <a:stretch/>
          </p:blipFill>
          <p:spPr>
            <a:xfrm>
              <a:off x="2236680" y="2957400"/>
              <a:ext cx="812160" cy="25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4"/>
            <a:srcRect l="34623" t="41381" r="23075" b="37800"/>
            <a:stretch/>
          </p:blipFill>
          <p:spPr>
            <a:xfrm>
              <a:off x="2241360" y="2557440"/>
              <a:ext cx="774360" cy="392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"/>
            <p:cNvSpPr/>
            <p:nvPr/>
          </p:nvSpPr>
          <p:spPr>
            <a:xfrm rot="16200000">
              <a:off x="1989720" y="179460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p27S10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6200000">
              <a:off x="2312640" y="1857600"/>
              <a:ext cx="59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p27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6200000">
              <a:off x="2525760" y="1795680"/>
              <a:ext cx="72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p27fs17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H="1">
              <a:off x="3009240" y="2666880"/>
              <a:ext cx="16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199960" y="2209680"/>
              <a:ext cx="0" cy="33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199960" y="2571840"/>
              <a:ext cx="0" cy="36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199960" y="2971800"/>
              <a:ext cx="0" cy="20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287720" y="2268360"/>
              <a:ext cx="996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IB: P-S10-p2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296720" y="2617920"/>
              <a:ext cx="60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IB: p2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303200" y="2948040"/>
              <a:ext cx="808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IB: tubul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6200000">
              <a:off x="3139200" y="179136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p27S10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rot="16200000">
              <a:off x="3462120" y="1854360"/>
              <a:ext cx="59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p27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rot="16200000">
              <a:off x="3674880" y="1792440"/>
              <a:ext cx="72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p27fs17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293720" y="2328840"/>
              <a:ext cx="60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IB: p2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343040" y="2209680"/>
              <a:ext cx="0" cy="54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319200" y="2754360"/>
              <a:ext cx="988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IP: P-S10-p2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339280" y="320184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000000"/>
                  </a:solidFill>
                  <a:latin typeface="Arial"/>
                </a:rPr>
                <a:t>W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"/>
          <p:cNvGrpSpPr/>
          <p:nvPr/>
        </p:nvGrpSpPr>
        <p:grpSpPr>
          <a:xfrm>
            <a:off x="4931280" y="1309680"/>
            <a:ext cx="2509200" cy="2525760"/>
            <a:chOff x="4931280" y="1309680"/>
            <a:chExt cx="2509200" cy="2525760"/>
          </a:xfrm>
        </p:grpSpPr>
        <p:sp>
          <p:nvSpPr>
            <p:cNvPr id="66" name=""/>
            <p:cNvSpPr/>
            <p:nvPr/>
          </p:nvSpPr>
          <p:spPr>
            <a:xfrm>
              <a:off x="6883560" y="1633680"/>
              <a:ext cx="0" cy="318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835320" y="1690560"/>
              <a:ext cx="543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IB: Cy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8" name="" descr=""/>
            <p:cNvPicPr/>
            <p:nvPr/>
          </p:nvPicPr>
          <p:blipFill>
            <a:blip r:embed="rId5"/>
            <a:srcRect l="3445" t="41395" r="28720" b="44383"/>
            <a:stretch/>
          </p:blipFill>
          <p:spPr>
            <a:xfrm>
              <a:off x="5156280" y="2001960"/>
              <a:ext cx="1687680" cy="363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"/>
            <p:cNvSpPr/>
            <p:nvPr/>
          </p:nvSpPr>
          <p:spPr>
            <a:xfrm>
              <a:off x="5671800" y="1309680"/>
              <a:ext cx="732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Clone 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0" name="" descr=""/>
            <p:cNvPicPr/>
            <p:nvPr/>
          </p:nvPicPr>
          <p:blipFill>
            <a:blip r:embed="rId6">
              <a:lum bright="6000"/>
            </a:blip>
            <a:srcRect l="0" t="0" r="0" b="64362"/>
            <a:stretch/>
          </p:blipFill>
          <p:spPr>
            <a:xfrm>
              <a:off x="5156280" y="1636560"/>
              <a:ext cx="1687680" cy="325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"/>
            <p:cNvSpPr/>
            <p:nvPr/>
          </p:nvSpPr>
          <p:spPr>
            <a:xfrm>
              <a:off x="6885000" y="1996920"/>
              <a:ext cx="0" cy="365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6836040" y="2046240"/>
              <a:ext cx="60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IB: CyD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6885000" y="2403360"/>
              <a:ext cx="0" cy="405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6886800" y="2841480"/>
              <a:ext cx="0" cy="263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6835680" y="2455920"/>
              <a:ext cx="59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IB: Cdk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835680" y="2833560"/>
              <a:ext cx="59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IB: Cdk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7" name="" descr=""/>
            <p:cNvPicPr/>
            <p:nvPr/>
          </p:nvPicPr>
          <p:blipFill>
            <a:blip r:embed="rId7"/>
            <a:srcRect l="2749" t="3347" r="30503" b="62405"/>
            <a:stretch/>
          </p:blipFill>
          <p:spPr>
            <a:xfrm>
              <a:off x="5148360" y="2408400"/>
              <a:ext cx="1695600" cy="390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" descr=""/>
            <p:cNvPicPr/>
            <p:nvPr/>
          </p:nvPicPr>
          <p:blipFill>
            <a:blip r:embed="rId8"/>
            <a:srcRect l="3748" t="43456" r="31100" b="33987"/>
            <a:stretch/>
          </p:blipFill>
          <p:spPr>
            <a:xfrm>
              <a:off x="5154840" y="2840040"/>
              <a:ext cx="1689120" cy="2570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9" name=""/>
            <p:cNvGrpSpPr/>
            <p:nvPr/>
          </p:nvGrpSpPr>
          <p:grpSpPr>
            <a:xfrm>
              <a:off x="4931280" y="3386160"/>
              <a:ext cx="1895040" cy="449280"/>
              <a:chOff x="4931280" y="3386160"/>
              <a:chExt cx="1895040" cy="449280"/>
            </a:xfrm>
          </p:grpSpPr>
          <p:sp>
            <p:nvSpPr>
              <p:cNvPr id="80" name=""/>
              <p:cNvSpPr/>
              <p:nvPr/>
            </p:nvSpPr>
            <p:spPr>
              <a:xfrm>
                <a:off x="5151960" y="3386160"/>
                <a:ext cx="1674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ss  pro    ss   pro    ss   pro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5257800" y="3600360"/>
                <a:ext cx="400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5772240" y="3600360"/>
                <a:ext cx="4129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6292800" y="3600360"/>
                <a:ext cx="4510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4931280" y="3589200"/>
                <a:ext cx="1805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1000" spc="-1" strike="noStrike">
                    <a:solidFill>
                      <a:srgbClr val="000000"/>
                    </a:solidFill>
                    <a:latin typeface="Arial"/>
                  </a:rPr>
                  <a:t>IP:    GFP      CycD1     Cyc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85" name="" descr=""/>
            <p:cNvPicPr/>
            <p:nvPr/>
          </p:nvPicPr>
          <p:blipFill>
            <a:blip r:embed="rId9"/>
            <a:srcRect l="50324" t="32524" r="14988" b="57383"/>
            <a:stretch/>
          </p:blipFill>
          <p:spPr>
            <a:xfrm>
              <a:off x="6221520" y="3130560"/>
              <a:ext cx="617400" cy="317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" descr=""/>
            <p:cNvPicPr/>
            <p:nvPr/>
          </p:nvPicPr>
          <p:blipFill>
            <a:blip r:embed="rId10"/>
            <a:srcRect l="40420" t="38389" r="15754" b="51518"/>
            <a:stretch/>
          </p:blipFill>
          <p:spPr>
            <a:xfrm>
              <a:off x="5157720" y="3132000"/>
              <a:ext cx="1060560" cy="317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"/>
            <p:cNvSpPr/>
            <p:nvPr/>
          </p:nvSpPr>
          <p:spPr>
            <a:xfrm>
              <a:off x="6886800" y="3159000"/>
              <a:ext cx="0" cy="2955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6835680" y="3208320"/>
              <a:ext cx="520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IB: p2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9" name=""/>
          <p:cNvSpPr/>
          <p:nvPr/>
        </p:nvSpPr>
        <p:spPr>
          <a:xfrm>
            <a:off x="475920" y="190440"/>
            <a:ext cx="145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dditional File 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8T10:41:58Z</dcterms:created>
  <dc:creator>natalia.pellegata</dc:creator>
  <dc:description/>
  <dc:language>en-US</dc:language>
  <cp:lastModifiedBy>natalia.pellegata</cp:lastModifiedBy>
  <dcterms:modified xsi:type="dcterms:W3CDTF">2010-05-18T10:42:06Z</dcterms:modified>
  <cp:revision>1</cp:revision>
  <dc:subject/>
  <dc:title>Slide 1</dc:title>
</cp:coreProperties>
</file>